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5D3B9A-3500-45BD-B061-F08DBA34B87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217406-A095-445E-9AF3-ACC87FDD7D8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B429E2-5B18-4DDF-8309-3B72132660B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56DC2C-5A1D-4CB3-BECA-3D7DB2F7B05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159568-4B98-4D36-93AF-957E70BC73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B7A27F-DD83-470C-8DC3-21C7ECCF62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26CBA0-A133-411D-88AD-3A62739D7C9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484640-2BDF-4691-A4B8-7656C510222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4A15C2-6C96-492B-B7B6-7ACBBD0B32F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2871E4-4E94-48AB-8C6D-DC90356D2B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D45C39-8E6D-4044-B63F-3E94F393F3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1439A8-9420-4C96-BD0F-839FFF7855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B2F964A-A204-4DE2-AE9E-40EFADC20A7A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8" descr=""/>
          <p:cNvPicPr/>
          <p:nvPr/>
        </p:nvPicPr>
        <p:blipFill>
          <a:blip r:embed="rId1"/>
          <a:srcRect l="0" t="7707" r="19298" b="8767"/>
          <a:stretch/>
        </p:blipFill>
        <p:spPr>
          <a:xfrm>
            <a:off x="3527280" y="2421000"/>
            <a:ext cx="2176560" cy="2157480"/>
          </a:xfrm>
          <a:prstGeom prst="rect">
            <a:avLst/>
          </a:prstGeom>
          <a:ln w="0">
            <a:noFill/>
          </a:ln>
        </p:spPr>
      </p:pic>
      <p:sp>
        <p:nvSpPr>
          <p:cNvPr id="42" name="ZoneTexte 2"/>
          <p:cNvSpPr/>
          <p:nvPr/>
        </p:nvSpPr>
        <p:spPr>
          <a:xfrm>
            <a:off x="4032360" y="2185920"/>
            <a:ext cx="576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  <a:ea typeface="Arial"/>
              </a:rPr>
              <a:t>DN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ZoneTexte 5"/>
          <p:cNvSpPr/>
          <p:nvPr/>
        </p:nvSpPr>
        <p:spPr>
          <a:xfrm>
            <a:off x="5129280" y="2176560"/>
            <a:ext cx="576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  <a:ea typeface="Arial"/>
              </a:rPr>
              <a:t>RN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ZoneTexte 2"/>
          <p:cNvSpPr/>
          <p:nvPr/>
        </p:nvSpPr>
        <p:spPr>
          <a:xfrm rot="16200000">
            <a:off x="2846520" y="1215720"/>
            <a:ext cx="20872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  <a:ea typeface="Arial"/>
              </a:rPr>
              <a:t>DNA Ladder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ZoneTexte 5"/>
          <p:cNvSpPr/>
          <p:nvPr/>
        </p:nvSpPr>
        <p:spPr>
          <a:xfrm>
            <a:off x="5861160" y="3429000"/>
            <a:ext cx="80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  <a:ea typeface="Arial"/>
              </a:rPr>
              <a:t>1627 p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ZoneTexte 5"/>
          <p:cNvSpPr/>
          <p:nvPr/>
        </p:nvSpPr>
        <p:spPr>
          <a:xfrm>
            <a:off x="2629080" y="3321000"/>
            <a:ext cx="86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  <a:ea typeface="Arial"/>
              </a:rPr>
              <a:t>2043 p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47" name="Connecteur droit avec flèche 24"/>
          <p:cNvCxnSpPr/>
          <p:nvPr/>
        </p:nvCxnSpPr>
        <p:spPr>
          <a:xfrm flipH="1">
            <a:off x="5653800" y="3576240"/>
            <a:ext cx="288360" cy="108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48" name="Connecteur droit avec flèche 26"/>
          <p:cNvCxnSpPr/>
          <p:nvPr/>
        </p:nvCxnSpPr>
        <p:spPr>
          <a:xfrm>
            <a:off x="3348000" y="3484080"/>
            <a:ext cx="720000" cy="1080"/>
          </a:xfrm>
          <a:prstGeom prst="straightConnector1">
            <a:avLst/>
          </a:prstGeom>
          <a:ln w="1260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49" name="ZoneTexte 2"/>
          <p:cNvSpPr/>
          <p:nvPr/>
        </p:nvSpPr>
        <p:spPr>
          <a:xfrm>
            <a:off x="3989520" y="4556160"/>
            <a:ext cx="653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  <a:ea typeface="Arial"/>
              </a:rPr>
              <a:t>U1/L18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ZoneTexte 2"/>
          <p:cNvSpPr/>
          <p:nvPr/>
        </p:nvSpPr>
        <p:spPr>
          <a:xfrm>
            <a:off x="5105520" y="4556160"/>
            <a:ext cx="653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  <a:ea typeface="Arial"/>
              </a:rPr>
              <a:t>U1/L2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Rectangle 15"/>
          <p:cNvSpPr/>
          <p:nvPr/>
        </p:nvSpPr>
        <p:spPr>
          <a:xfrm>
            <a:off x="193680" y="9345600"/>
            <a:ext cx="380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800" spc="-1" strike="noStrike">
                <a:solidFill>
                  <a:srgbClr val="0000ff"/>
                </a:solidFill>
                <a:latin typeface="Calibri"/>
              </a:rPr>
              <a:t>Supplemental figure 2 : Meseure et al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Rectangle 16"/>
          <p:cNvSpPr/>
          <p:nvPr/>
        </p:nvSpPr>
        <p:spPr>
          <a:xfrm>
            <a:off x="372960" y="9524880"/>
            <a:ext cx="380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800" spc="-1" strike="noStrike">
                <a:solidFill>
                  <a:srgbClr val="0000ff"/>
                </a:solidFill>
                <a:latin typeface="Calibri"/>
              </a:rPr>
              <a:t>Supplemental figure 2 : Meseure et al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Rectangle 17"/>
          <p:cNvSpPr/>
          <p:nvPr/>
        </p:nvSpPr>
        <p:spPr>
          <a:xfrm>
            <a:off x="552600" y="9704520"/>
            <a:ext cx="380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800" spc="-1" strike="noStrike">
                <a:solidFill>
                  <a:srgbClr val="0000ff"/>
                </a:solidFill>
                <a:latin typeface="Calibri"/>
              </a:rPr>
              <a:t>Supplemental figure 2 : Meseure et al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Rectangle 18"/>
          <p:cNvSpPr/>
          <p:nvPr/>
        </p:nvSpPr>
        <p:spPr>
          <a:xfrm>
            <a:off x="217440" y="6256440"/>
            <a:ext cx="3800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800" spc="-1" strike="noStrike">
                <a:solidFill>
                  <a:srgbClr val="0000ff"/>
                </a:solidFill>
                <a:latin typeface="Calibri"/>
              </a:rPr>
              <a:t>Supplemental figure 1 : Meseure et al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ZoneTexte 2"/>
          <p:cNvSpPr/>
          <p:nvPr/>
        </p:nvSpPr>
        <p:spPr>
          <a:xfrm rot="16200000">
            <a:off x="3902040" y="1204560"/>
            <a:ext cx="20876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  <a:ea typeface="Arial"/>
              </a:rPr>
              <a:t>DNA Ladder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5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1-29T13:54:38Z</dcterms:created>
  <dc:creator>Institut Curie</dc:creator>
  <dc:description/>
  <dc:language>en-US</dc:language>
  <cp:lastModifiedBy>Institut Curie</cp:lastModifiedBy>
  <cp:lastPrinted>2016-02-10T10:15:10Z</cp:lastPrinted>
  <dcterms:modified xsi:type="dcterms:W3CDTF">2016-02-16T08:16:54Z</dcterms:modified>
  <cp:revision>37</cp:revision>
  <dc:subject/>
  <dc:title>Présentation PowerPoint</dc:title>
</cp:coreProperties>
</file>